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84" r:id="rId2"/>
    <p:sldId id="285" r:id="rId3"/>
    <p:sldId id="286" r:id="rId4"/>
    <p:sldId id="305" r:id="rId5"/>
    <p:sldId id="306" r:id="rId6"/>
    <p:sldId id="281" r:id="rId7"/>
    <p:sldId id="28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481" autoAdjust="0"/>
    <p:restoredTop sz="94660"/>
  </p:normalViewPr>
  <p:slideViewPr>
    <p:cSldViewPr snapToGrid="0">
      <p:cViewPr varScale="1">
        <p:scale>
          <a:sx n="74" d="100"/>
          <a:sy n="74" d="100"/>
        </p:scale>
        <p:origin x="4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cha\Documents\LECTURESHIP\Research\NC3Rs%20Paper%202\Oestradiol-%20TK6-%2048hr%20exposure%20%20%20RPD%20after%2023h%20recovery%20time%20Kulsoom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echa\Documents\LECTURESHIP\Research\NC3Rs%20Paper%202\RPD%20after%20recovery%20time%20with%20Cycloheximide%20Kulsoom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dirty="0"/>
              <a:t>b. Oestradiol</a:t>
            </a:r>
            <a:r>
              <a:rPr lang="en-GB" baseline="0" dirty="0"/>
              <a:t> (48h + 23h)</a:t>
            </a:r>
            <a:endParaRPr lang="en-GB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 48h exp &amp; 23hrs recove '!$V$14</c:f>
              <c:strCache>
                <c:ptCount val="1"/>
                <c:pt idx="0">
                  <c:v>% MN/BN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Lbls>
            <c:dLbl>
              <c:idx val="4"/>
              <c:layout>
                <c:manualLayout>
                  <c:x val="-8.8447256185039957E-2"/>
                  <c:y val="-2.9732338717669983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900" b="0" i="0" u="none" strike="noStrike" kern="1200" baseline="0">
                        <a:solidFill>
                          <a:srgbClr val="FF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2000" dirty="0">
                        <a:solidFill>
                          <a:srgbClr val="FF0000"/>
                        </a:solidFill>
                      </a:rPr>
                      <a:t>*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900" b="0" i="0" u="none" strike="noStrike" kern="1200" baseline="0">
                      <a:solidFill>
                        <a:srgbClr val="FF0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2-E3D1-4F88-93BE-0A1E7B799A07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Dir val="y"/>
            <c:errBarType val="both"/>
            <c:errValType val="cust"/>
            <c:noEndCap val="0"/>
            <c:plus>
              <c:numRef>
                <c:f>' 48h exp &amp; 23hrs recove '!$X$15:$X$22</c:f>
                <c:numCache>
                  <c:formatCode>General</c:formatCode>
                  <c:ptCount val="8"/>
                  <c:pt idx="0">
                    <c:v>0.11086778913041723</c:v>
                  </c:pt>
                  <c:pt idx="1">
                    <c:v>5.6199051000291274E-2</c:v>
                  </c:pt>
                  <c:pt idx="2">
                    <c:v>0.90496316683792899</c:v>
                  </c:pt>
                  <c:pt idx="3">
                    <c:v>0.15478479684172267</c:v>
                  </c:pt>
                  <c:pt idx="4">
                    <c:v>0.95350231602585334</c:v>
                  </c:pt>
                  <c:pt idx="5">
                    <c:v>0.16997548842896901</c:v>
                  </c:pt>
                  <c:pt idx="6">
                    <c:v>3.2890626830957985</c:v>
                  </c:pt>
                </c:numCache>
              </c:numRef>
            </c:plus>
            <c:minus>
              <c:numRef>
                <c:f>' 48h exp &amp; 23hrs recove '!$X$15:$X$22</c:f>
                <c:numCache>
                  <c:formatCode>General</c:formatCode>
                  <c:ptCount val="8"/>
                  <c:pt idx="0">
                    <c:v>0.11086778913041723</c:v>
                  </c:pt>
                  <c:pt idx="1">
                    <c:v>5.6199051000291274E-2</c:v>
                  </c:pt>
                  <c:pt idx="2">
                    <c:v>0.90496316683792899</c:v>
                  </c:pt>
                  <c:pt idx="3">
                    <c:v>0.15478479684172267</c:v>
                  </c:pt>
                  <c:pt idx="4">
                    <c:v>0.95350231602585334</c:v>
                  </c:pt>
                  <c:pt idx="5">
                    <c:v>0.16997548842896901</c:v>
                  </c:pt>
                  <c:pt idx="6">
                    <c:v>3.28906268309579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 48h exp &amp; 23hrs recove '!$U$15:$U$22</c:f>
              <c:numCache>
                <c:formatCode>General</c:formatCode>
                <c:ptCount val="8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80</c:v>
                </c:pt>
              </c:numCache>
            </c:numRef>
          </c:cat>
          <c:val>
            <c:numRef>
              <c:f>' 48h exp &amp; 23hrs recove '!$V$15:$V$22</c:f>
              <c:numCache>
                <c:formatCode>General</c:formatCode>
                <c:ptCount val="8"/>
                <c:pt idx="0">
                  <c:v>1.0874999999999999</c:v>
                </c:pt>
                <c:pt idx="1">
                  <c:v>1.2424999999999999</c:v>
                </c:pt>
                <c:pt idx="2">
                  <c:v>1.3374999999999999</c:v>
                </c:pt>
                <c:pt idx="3">
                  <c:v>2.4874999999999998</c:v>
                </c:pt>
                <c:pt idx="4">
                  <c:v>3.375</c:v>
                </c:pt>
                <c:pt idx="5">
                  <c:v>4.8574999999999999</c:v>
                </c:pt>
                <c:pt idx="6">
                  <c:v>4.9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3D1-4F88-93BE-0A1E7B799A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29849296"/>
        <c:axId val="1429855824"/>
      </c:lineChart>
      <c:lineChart>
        <c:grouping val="standard"/>
        <c:varyColors val="0"/>
        <c:ser>
          <c:idx val="1"/>
          <c:order val="1"/>
          <c:tx>
            <c:strRef>
              <c:f>' 48h exp &amp; 23hrs recove '!$W$14</c:f>
              <c:strCache>
                <c:ptCount val="1"/>
                <c:pt idx="0">
                  <c:v>RPD (%)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48h exp &amp; 23hrs recove '!$Y$15:$Y$22</c:f>
                <c:numCache>
                  <c:formatCode>General</c:formatCode>
                  <c:ptCount val="8"/>
                  <c:pt idx="0">
                    <c:v>6.6344537534530117</c:v>
                  </c:pt>
                  <c:pt idx="2">
                    <c:v>24.167751880756921</c:v>
                  </c:pt>
                  <c:pt idx="4">
                    <c:v>37.069029208040298</c:v>
                  </c:pt>
                  <c:pt idx="6">
                    <c:v>66.829718712099506</c:v>
                  </c:pt>
                  <c:pt idx="7">
                    <c:v>0</c:v>
                  </c:pt>
                </c:numCache>
              </c:numRef>
            </c:plus>
            <c:minus>
              <c:numRef>
                <c:f>' 48h exp &amp; 23hrs recove '!$Y$15:$Y$22</c:f>
                <c:numCache>
                  <c:formatCode>General</c:formatCode>
                  <c:ptCount val="8"/>
                  <c:pt idx="0">
                    <c:v>6.6344537534530117</c:v>
                  </c:pt>
                  <c:pt idx="2">
                    <c:v>24.167751880756921</c:v>
                  </c:pt>
                  <c:pt idx="4">
                    <c:v>37.069029208040298</c:v>
                  </c:pt>
                  <c:pt idx="6">
                    <c:v>66.829718712099506</c:v>
                  </c:pt>
                  <c:pt idx="7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 48h exp &amp; 23hrs recove '!$U$15:$U$22</c:f>
              <c:numCache>
                <c:formatCode>General</c:formatCode>
                <c:ptCount val="8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80</c:v>
                </c:pt>
              </c:numCache>
            </c:numRef>
          </c:cat>
          <c:val>
            <c:numRef>
              <c:f>' 48h exp &amp; 23hrs recove '!$W$15:$W$22</c:f>
              <c:numCache>
                <c:formatCode>General</c:formatCode>
                <c:ptCount val="8"/>
                <c:pt idx="0">
                  <c:v>100.80487874919883</c:v>
                </c:pt>
                <c:pt idx="2">
                  <c:v>91.133869018262743</c:v>
                </c:pt>
                <c:pt idx="4">
                  <c:v>46.646823419246218</c:v>
                </c:pt>
                <c:pt idx="6">
                  <c:v>1.3867561384606759</c:v>
                </c:pt>
                <c:pt idx="7">
                  <c:v>-39.08796816043075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3D1-4F88-93BE-0A1E7B799A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29856912"/>
        <c:axId val="1429856368"/>
      </c:lineChart>
      <c:catAx>
        <c:axId val="14298492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>
                    <a:latin typeface="+mj-lt"/>
                  </a:rPr>
                  <a:t>Oestradiol (</a:t>
                </a:r>
                <a:r>
                  <a:rPr lang="en-GB" dirty="0">
                    <a:latin typeface="+mj-lt"/>
                    <a:cs typeface="Times New Roman" panose="02020603050405020304" pitchFamily="18" charset="0"/>
                  </a:rPr>
                  <a:t>µM)</a:t>
                </a:r>
                <a:endParaRPr lang="en-GB" dirty="0">
                  <a:latin typeface="+mj-lt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9855824"/>
        <c:crosses val="autoZero"/>
        <c:auto val="1"/>
        <c:lblAlgn val="ctr"/>
        <c:lblOffset val="100"/>
        <c:noMultiLvlLbl val="0"/>
      </c:catAx>
      <c:valAx>
        <c:axId val="14298558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/>
                  <a:t>% MN/BN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9849296"/>
        <c:crosses val="autoZero"/>
        <c:crossBetween val="between"/>
      </c:valAx>
      <c:valAx>
        <c:axId val="1429856368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/>
                  <a:t>RPD (%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29856912"/>
        <c:crosses val="max"/>
        <c:crossBetween val="between"/>
      </c:valAx>
      <c:catAx>
        <c:axId val="142985691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42985636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400" b="0" dirty="0"/>
              <a:t>a. Cycloheximide (23h + 23h)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1"/>
          <c:tx>
            <c:v>% MN/BN</c:v>
          </c:tx>
          <c:spPr>
            <a:ln>
              <a:solidFill>
                <a:schemeClr val="accent2"/>
              </a:solidFill>
            </a:ln>
          </c:spPr>
          <c:marker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dLbls>
            <c:dLbl>
              <c:idx val="2"/>
              <c:layout>
                <c:manualLayout>
                  <c:x val="-7.3021443708954248E-2"/>
                  <c:y val="-9.8208138494096611E-2"/>
                </c:manualLayout>
              </c:layout>
              <c:tx>
                <c:rich>
                  <a:bodyPr/>
                  <a:lstStyle/>
                  <a:p>
                    <a:r>
                      <a:rPr lang="en-US" sz="2000">
                        <a:solidFill>
                          <a:srgbClr val="FF0000"/>
                        </a:solidFill>
                      </a:rPr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0-5BEF-4DB3-94B7-7EB8C8FE2D78}"/>
                </c:ext>
                <c:ext xmlns:c15="http://schemas.microsoft.com/office/drawing/2012/chart" uri="{CE6537A1-D6FC-4f65-9D91-7224C49458BB}">
                  <c15:layout>
                    <c:manualLayout>
                      <c:w val="7.7991631799163186E-2"/>
                      <c:h val="0.12714223478575554"/>
                    </c:manualLayout>
                  </c15:layout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y"/>
            <c:errBarType val="both"/>
            <c:errValType val="cust"/>
            <c:noEndCap val="0"/>
            <c:plus>
              <c:numRef>
                <c:f>'Cycloheximide 23h RPD'!$AD$4:$AD$7</c:f>
                <c:numCache>
                  <c:formatCode>General</c:formatCode>
                  <c:ptCount val="4"/>
                  <c:pt idx="0">
                    <c:v>2.5513175269295828E-2</c:v>
                  </c:pt>
                  <c:pt idx="1">
                    <c:v>0.24740797094186112</c:v>
                  </c:pt>
                  <c:pt idx="2">
                    <c:v>0.3181128787857847</c:v>
                  </c:pt>
                  <c:pt idx="3">
                    <c:v>0.63407003267468343</c:v>
                  </c:pt>
                </c:numCache>
              </c:numRef>
            </c:plus>
            <c:minus>
              <c:numRef>
                <c:f>'Cycloheximide 23h RPD'!$AD$4:$AD$7</c:f>
                <c:numCache>
                  <c:formatCode>General</c:formatCode>
                  <c:ptCount val="4"/>
                  <c:pt idx="0">
                    <c:v>2.5513175269295828E-2</c:v>
                  </c:pt>
                  <c:pt idx="1">
                    <c:v>0.24740797094186112</c:v>
                  </c:pt>
                  <c:pt idx="2">
                    <c:v>0.3181128787857847</c:v>
                  </c:pt>
                  <c:pt idx="3">
                    <c:v>0.63407003267468343</c:v>
                  </c:pt>
                </c:numCache>
              </c:numRef>
            </c:minus>
          </c:errBars>
          <c:xVal>
            <c:numRef>
              <c:f>'Cycloheximide 23h RPD'!$P$4:$P$7</c:f>
              <c:numCache>
                <c:formatCode>General</c:formatCode>
                <c:ptCount val="4"/>
                <c:pt idx="0">
                  <c:v>0</c:v>
                </c:pt>
                <c:pt idx="1">
                  <c:v>0.7</c:v>
                </c:pt>
                <c:pt idx="2">
                  <c:v>1.1000000000000001</c:v>
                </c:pt>
                <c:pt idx="3">
                  <c:v>1.4</c:v>
                </c:pt>
              </c:numCache>
            </c:numRef>
          </c:xVal>
          <c:yVal>
            <c:numRef>
              <c:f>'Cycloheximide 23h RPD'!$AC$4:$AC$7</c:f>
              <c:numCache>
                <c:formatCode>General</c:formatCode>
                <c:ptCount val="4"/>
                <c:pt idx="0">
                  <c:v>1.0517803028634551</c:v>
                </c:pt>
                <c:pt idx="1">
                  <c:v>1.4829087936079741</c:v>
                </c:pt>
                <c:pt idx="2">
                  <c:v>1.8580247997678008</c:v>
                </c:pt>
                <c:pt idx="3">
                  <c:v>2.012779524015402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5BEF-4DB3-94B7-7EB8C8FE2D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29858000"/>
        <c:axId val="1429858544"/>
      </c:scatterChart>
      <c:scatterChart>
        <c:scatterStyle val="lineMarker"/>
        <c:varyColors val="0"/>
        <c:ser>
          <c:idx val="1"/>
          <c:order val="0"/>
          <c:tx>
            <c:strRef>
              <c:f>'Cycloheximide 23h RPD'!$Y$3</c:f>
              <c:strCache>
                <c:ptCount val="1"/>
                <c:pt idx="0">
                  <c:v>%RPD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chemeClr val="accent1"/>
              </a:solidFill>
              <a:ln w="3175"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ycloheximide 23h RPD'!$Z$4:$Z$1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5.106183567429202</c:v>
                  </c:pt>
                  <c:pt idx="2">
                    <c:v>11.894145809937493</c:v>
                  </c:pt>
                  <c:pt idx="3">
                    <c:v>3.6937742975615526</c:v>
                  </c:pt>
                  <c:pt idx="4">
                    <c:v>10.187404553433499</c:v>
                  </c:pt>
                  <c:pt idx="5">
                    <c:v>5.317502841713786</c:v>
                  </c:pt>
                  <c:pt idx="6">
                    <c:v>3.6554154788424809</c:v>
                  </c:pt>
                </c:numCache>
              </c:numRef>
            </c:plus>
            <c:minus>
              <c:numRef>
                <c:f>'Cycloheximide 23h RPD'!$Z$4:$Z$1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5.106183567429202</c:v>
                  </c:pt>
                  <c:pt idx="2">
                    <c:v>11.894145809937493</c:v>
                  </c:pt>
                  <c:pt idx="3">
                    <c:v>3.6937742975615526</c:v>
                  </c:pt>
                  <c:pt idx="4">
                    <c:v>10.187404553433499</c:v>
                  </c:pt>
                  <c:pt idx="5">
                    <c:v>5.317502841713786</c:v>
                  </c:pt>
                  <c:pt idx="6">
                    <c:v>3.6554154788424809</c:v>
                  </c:pt>
                </c:numCache>
              </c:numRef>
            </c:minus>
          </c:errBars>
          <c:xVal>
            <c:numRef>
              <c:f>'Cycloheximide 23h RPD'!$P$4:$P$7</c:f>
              <c:numCache>
                <c:formatCode>General</c:formatCode>
                <c:ptCount val="4"/>
                <c:pt idx="0">
                  <c:v>0</c:v>
                </c:pt>
                <c:pt idx="1">
                  <c:v>0.7</c:v>
                </c:pt>
                <c:pt idx="2">
                  <c:v>1.1000000000000001</c:v>
                </c:pt>
                <c:pt idx="3">
                  <c:v>1.4</c:v>
                </c:pt>
              </c:numCache>
            </c:numRef>
          </c:xVal>
          <c:yVal>
            <c:numRef>
              <c:f>'Cycloheximide 23h RPD'!$Y$4:$Y$7</c:f>
              <c:numCache>
                <c:formatCode>General</c:formatCode>
                <c:ptCount val="4"/>
                <c:pt idx="0">
                  <c:v>100</c:v>
                </c:pt>
                <c:pt idx="1">
                  <c:v>72.090724629604424</c:v>
                </c:pt>
                <c:pt idx="2">
                  <c:v>54.479873737950946</c:v>
                </c:pt>
                <c:pt idx="3">
                  <c:v>49.96190364630067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5BEF-4DB3-94B7-7EB8C8FE2D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30850656"/>
        <c:axId val="1430849024"/>
      </c:scatterChart>
      <c:valAx>
        <c:axId val="14298580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Cycloheximide (µ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bg1">
                <a:lumMod val="85000"/>
              </a:schemeClr>
            </a:solidFill>
          </a:ln>
        </c:spPr>
        <c:crossAx val="1429858544"/>
        <c:crosses val="autoZero"/>
        <c:crossBetween val="midCat"/>
      </c:valAx>
      <c:valAx>
        <c:axId val="1429858544"/>
        <c:scaling>
          <c:orientation val="minMax"/>
          <c:max val="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MN/B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bg1">
                <a:lumMod val="85000"/>
              </a:schemeClr>
            </a:solidFill>
          </a:ln>
        </c:spPr>
        <c:crossAx val="1429858000"/>
        <c:crosses val="autoZero"/>
        <c:crossBetween val="midCat"/>
      </c:valAx>
      <c:valAx>
        <c:axId val="1430849024"/>
        <c:scaling>
          <c:orientation val="minMax"/>
          <c:max val="150"/>
        </c:scaling>
        <c:delete val="0"/>
        <c:axPos val="r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RPD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bg1">
                <a:lumMod val="85000"/>
              </a:schemeClr>
            </a:solidFill>
          </a:ln>
        </c:spPr>
        <c:crossAx val="1430850656"/>
        <c:crosses val="max"/>
        <c:crossBetween val="midCat"/>
      </c:valAx>
      <c:valAx>
        <c:axId val="143085065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43084902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>
          <a:solidFill>
            <a:schemeClr val="bg1">
              <a:lumMod val="50000"/>
            </a:schemeClr>
          </a:solidFill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D46BD5-8768-4AE2-B3BC-923836BE8110}" type="datetimeFigureOut">
              <a:rPr lang="en-GB" smtClean="0"/>
              <a:t>04/09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6BE389-254D-43FC-81D1-820F9EC5A0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542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No significant</a:t>
            </a:r>
            <a:r>
              <a:rPr lang="en-US" baseline="0" dirty="0"/>
              <a:t> change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E16ED4-E535-5743-BDCF-1DE1FA4A097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58843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indent="-285750">
              <a:buFont typeface="Arial" charset="0"/>
              <a:buChar char="•"/>
            </a:pPr>
            <a:r>
              <a:rPr lang="en-US" b="1" dirty="0"/>
              <a:t>CHX induces </a:t>
            </a:r>
            <a:r>
              <a:rPr lang="en-US" b="1" dirty="0" err="1"/>
              <a:t>Mni</a:t>
            </a:r>
            <a:r>
              <a:rPr lang="en-US" b="1" dirty="0"/>
              <a:t> after 4h+23h (Completed</a:t>
            </a:r>
            <a:r>
              <a:rPr lang="en-US" b="1" baseline="0" dirty="0"/>
              <a:t> by </a:t>
            </a:r>
            <a:r>
              <a:rPr lang="en-US" b="1" baseline="0" dirty="0" err="1"/>
              <a:t>Kulsoom</a:t>
            </a:r>
            <a:r>
              <a:rPr lang="en-US" b="1" baseline="0" dirty="0"/>
              <a:t>)</a:t>
            </a:r>
            <a:endParaRPr lang="en-US" b="1" dirty="0"/>
          </a:p>
          <a:p>
            <a:pPr marL="285750" indent="-285750">
              <a:buFont typeface="Arial" charset="0"/>
              <a:buChar char="•"/>
            </a:pPr>
            <a:r>
              <a:rPr lang="en-US" dirty="0"/>
              <a:t>Caffeine and CHX both negative at 4h</a:t>
            </a:r>
            <a:r>
              <a:rPr lang="en-US" baseline="0" dirty="0"/>
              <a:t>+23h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7D8A07D-05C9-AC4D-839F-11E327DD05A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93597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F4F4078-B60E-6846-937F-F1C1BB69135D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9444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03B85B3-452F-41B3-B7E7-232CB42843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948CC094-5454-4EC4-8F7F-40279BF945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05C7231-462F-4F92-A43C-4643A73B36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C6E32-8D40-4FBD-833A-EEFE7044ADBE}" type="datetimeFigureOut">
              <a:rPr lang="en-GB" smtClean="0"/>
              <a:t>04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78A965E-346A-4D24-AF83-162EEA721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E2C5462-E335-4458-B478-3B501CF4B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CA13C-C129-4614-8350-A325EA782F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5053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22343A6-1697-41CB-B4B9-21DCC6E759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B665D0CF-D415-4546-98E4-267E574B44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730B4AA-13F4-4F61-BA33-D36295E3D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C6E32-8D40-4FBD-833A-EEFE7044ADBE}" type="datetimeFigureOut">
              <a:rPr lang="en-GB" smtClean="0"/>
              <a:t>04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E4D32E8-9370-43DC-BA0D-3AE35ED89D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56940F4-4368-462E-8FC5-91FE005F4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CA13C-C129-4614-8350-A325EA782F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6135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096BE8DB-4E28-484C-A888-A620A21F9B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47AD5D3-652E-49A7-9A09-345BC9FE57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A488D33-3780-4517-90C9-4394FC7E87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C6E32-8D40-4FBD-833A-EEFE7044ADBE}" type="datetimeFigureOut">
              <a:rPr lang="en-GB" smtClean="0"/>
              <a:t>04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19FD750-D755-4BBD-8F34-9FCBB5B82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87076FE-E023-4639-874A-F22AD07EDA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CA13C-C129-4614-8350-A325EA782F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4757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D13CD61-8C61-4D21-9F39-66A2F72D2B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64A16B2-07B4-4BCC-96E5-E6A15AEBF5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2F20FEF-7FEB-4B99-8458-80BB77227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C6E32-8D40-4FBD-833A-EEFE7044ADBE}" type="datetimeFigureOut">
              <a:rPr lang="en-GB" smtClean="0"/>
              <a:t>04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5AC4292-69A0-41A2-A415-1BAE47B61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65E8A54-A7F4-4F80-86D8-863325E916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CA13C-C129-4614-8350-A325EA782F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4664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CF04731-0B7A-487F-8A19-78DEC12819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F81A2CB-4935-4F7D-BCE8-D3038BB52A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D89DAE9-205C-4BC7-9680-CBA0E9FFE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C6E32-8D40-4FBD-833A-EEFE7044ADBE}" type="datetimeFigureOut">
              <a:rPr lang="en-GB" smtClean="0"/>
              <a:t>04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2613A81-4687-42AD-A730-60DB77B4B8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A112A76-3232-490D-8EEA-D085EECAF1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CA13C-C129-4614-8350-A325EA782F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7308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D434E54-7EEE-4911-B9E4-F50616364E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0209978-B546-43D7-ABDF-9D6882434B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6E6BDBC0-9306-4D90-8369-C7DE9C54E5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A27B4CEA-1DFC-4902-8ED5-9B441FE2A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C6E32-8D40-4FBD-833A-EEFE7044ADBE}" type="datetimeFigureOut">
              <a:rPr lang="en-GB" smtClean="0"/>
              <a:t>04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390D2D3-ACE9-449C-AFBA-B573A06A0C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73E1675-B2F8-4B62-AC0B-990EF376B7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CA13C-C129-4614-8350-A325EA782F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10453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8C7CFB2-DFBC-4421-B5F9-D01E896FD6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EE4CF73-93DF-4D7B-8D93-7ACC59C6B1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0C9838E-F93E-414C-A9F3-4183BBDA1A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437B7631-FB82-4480-A1BF-93F33C59DE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3144C778-6BBB-4700-A7F0-9DAB1A12F7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E9931098-2329-4053-8586-3F2B16EC3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C6E32-8D40-4FBD-833A-EEFE7044ADBE}" type="datetimeFigureOut">
              <a:rPr lang="en-GB" smtClean="0"/>
              <a:t>04/09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466754C1-4CA5-407D-999C-8F5C91DC23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A2BE053C-2FA4-4B5D-89A1-237E33C84F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CA13C-C129-4614-8350-A325EA782F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7698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59F755E-15AB-44EB-9776-C091FC44C6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BB849E70-2E1B-4A63-A770-710B73214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C6E32-8D40-4FBD-833A-EEFE7044ADBE}" type="datetimeFigureOut">
              <a:rPr lang="en-GB" smtClean="0"/>
              <a:t>04/09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E42CA679-D7BF-4580-8CFA-0EF5293ED0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738EE7F1-2DA1-4495-9D53-C1487CD499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CA13C-C129-4614-8350-A325EA782F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97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432BC0E6-1CFB-4492-B3E5-626DC87F7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C6E32-8D40-4FBD-833A-EEFE7044ADBE}" type="datetimeFigureOut">
              <a:rPr lang="en-GB" smtClean="0"/>
              <a:t>04/09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756D759E-0CD5-4B81-8422-37D0F375B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A75966E4-5405-40CD-8DB7-761DB1F54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CA13C-C129-4614-8350-A325EA782F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4568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6EC4390-1396-44C0-B1AB-37BEFFC73C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46F9B0E-9634-47C2-AB0C-9F31E82C9C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EC729BD-C4B2-4BF6-B33B-CB122BDBCB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75D92C3-31A9-4BCD-9580-3B7F9B8C8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C6E32-8D40-4FBD-833A-EEFE7044ADBE}" type="datetimeFigureOut">
              <a:rPr lang="en-GB" smtClean="0"/>
              <a:t>04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B81CD08-4918-4CD7-BF15-B711DDD846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04146E69-5E03-4735-895E-A0C2DBF8D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CA13C-C129-4614-8350-A325EA782F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153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8F04FCC-9115-4C51-8968-3D1D968F6F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1F52C5FD-15C1-41E6-B30D-7B38BA33DC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3829467-700D-45C1-8DB9-C2B502B896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632C335-DC8D-4695-A02D-86FA81A4E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C6E32-8D40-4FBD-833A-EEFE7044ADBE}" type="datetimeFigureOut">
              <a:rPr lang="en-GB" smtClean="0"/>
              <a:t>04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238BB66-3112-49B6-8E96-29547FB62E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CA0A8B3-2343-4A71-96AD-9CA260DEF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CA13C-C129-4614-8350-A325EA782F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4875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CB722A98-F059-494A-9088-61F1EDFA0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F67681E-522B-4333-B00A-0CCB2D79D3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A7B7B8C-B0A0-4C18-A435-FA1E5A1ECB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3C6E32-8D40-4FBD-833A-EEFE7044ADBE}" type="datetimeFigureOut">
              <a:rPr lang="en-GB" smtClean="0"/>
              <a:t>04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3343F4B-80DB-4606-88C3-E8FDB01517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9BE5BDF-20F5-42BF-832C-94E499E7A6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3CA13C-C129-4614-8350-A325EA782F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3916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3000" dirty="0"/>
              <a:t>Online resources</a:t>
            </a:r>
            <a:br>
              <a:rPr lang="en-US" sz="3000" dirty="0"/>
            </a:br>
            <a:r>
              <a:rPr lang="en-US" sz="3000" dirty="0"/>
              <a:t>(Electronic supplementary files)</a:t>
            </a:r>
          </a:p>
        </p:txBody>
      </p:sp>
    </p:spTree>
    <p:extLst>
      <p:ext uri="{BB962C8B-B14F-4D97-AF65-F5344CB8AC3E}">
        <p14:creationId xmlns:p14="http://schemas.microsoft.com/office/powerpoint/2010/main" val="1634721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812474" y="2280804"/>
            <a:ext cx="676101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/>
              <a:t>Online resource 1 </a:t>
            </a:r>
            <a:r>
              <a:rPr lang="en-US" sz="2000" dirty="0"/>
              <a:t>Cytokinesis blocked micronucleus (CBMN) assay results for longer exposure times performed in addition to the experiments in Figure 1. Elongated exposure periods were performed for A. Cycloheximide and B. </a:t>
            </a:r>
            <a:r>
              <a:rPr lang="en-US" sz="2000" dirty="0" err="1"/>
              <a:t>Oestradiol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308699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xmlns="" id="{1B553E03-B7A2-42AA-9946-3CF3E1A6A2B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7266339"/>
              </p:ext>
            </p:extLst>
          </p:nvPr>
        </p:nvGraphicFramePr>
        <p:xfrm>
          <a:off x="6456218" y="2064930"/>
          <a:ext cx="3340328" cy="26665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E5ED9A65-B558-45F6-9CDA-0BBCB4830C82}"/>
              </a:ext>
            </a:extLst>
          </p:cNvPr>
          <p:cNvSpPr txBox="1"/>
          <p:nvPr/>
        </p:nvSpPr>
        <p:spPr>
          <a:xfrm>
            <a:off x="8298872" y="2542420"/>
            <a:ext cx="637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FF0000"/>
                </a:solidFill>
              </a:rPr>
              <a:t>***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xmlns="" id="{4EC31DFD-E75E-447B-9EE1-C6373BB30075}"/>
              </a:ext>
            </a:extLst>
          </p:cNvPr>
          <p:cNvCxnSpPr>
            <a:cxnSpLocks/>
          </p:cNvCxnSpPr>
          <p:nvPr/>
        </p:nvCxnSpPr>
        <p:spPr>
          <a:xfrm flipH="1">
            <a:off x="8382000" y="2791805"/>
            <a:ext cx="401780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xmlns="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8868631"/>
              </p:ext>
            </p:extLst>
          </p:nvPr>
        </p:nvGraphicFramePr>
        <p:xfrm>
          <a:off x="2211178" y="2050474"/>
          <a:ext cx="3340327" cy="24980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5080623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C07A301D-A825-4E42-BFF0-4CE7E6FEA286}"/>
              </a:ext>
            </a:extLst>
          </p:cNvPr>
          <p:cNvSpPr txBox="1"/>
          <p:nvPr/>
        </p:nvSpPr>
        <p:spPr>
          <a:xfrm>
            <a:off x="2812474" y="2280804"/>
            <a:ext cx="676101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/>
              <a:t>Online resource 2 </a:t>
            </a:r>
            <a:r>
              <a:rPr lang="en-US" sz="2000" dirty="0"/>
              <a:t>Western blotting results for quercetin (4h) to determine the change in expression of p53 and phospho-p53, with significant changes highlighted in red. Doses selected were based on the MN and RPD data generated previously (</a:t>
            </a:r>
            <a:r>
              <a:rPr lang="en-US" sz="2000" b="1" dirty="0"/>
              <a:t>Figure 1</a:t>
            </a:r>
            <a:r>
              <a:rPr lang="en-US" sz="2000" dirty="0"/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39619494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8C3E99BC-2863-46FB-B9B6-F8EEF5A88E62}"/>
              </a:ext>
            </a:extLst>
          </p:cNvPr>
          <p:cNvGrpSpPr/>
          <p:nvPr/>
        </p:nvGrpSpPr>
        <p:grpSpPr>
          <a:xfrm>
            <a:off x="2317130" y="2826553"/>
            <a:ext cx="7889096" cy="1041548"/>
            <a:chOff x="303073" y="1221392"/>
            <a:chExt cx="7481172" cy="1971236"/>
          </a:xfrm>
        </p:grpSpPr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xmlns="" id="{B277C342-FF79-4435-ABCE-501BBFF1DD25}"/>
                </a:ext>
              </a:extLst>
            </p:cNvPr>
            <p:cNvSpPr/>
            <p:nvPr/>
          </p:nvSpPr>
          <p:spPr>
            <a:xfrm>
              <a:off x="365519" y="1974029"/>
              <a:ext cx="4219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dirty="0"/>
                <a:t>p53</a:t>
              </a:r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xmlns="" id="{F8C37E68-F61B-4D7D-879A-91893EE0B892}"/>
                </a:ext>
              </a:extLst>
            </p:cNvPr>
            <p:cNvSpPr/>
            <p:nvPr/>
          </p:nvSpPr>
          <p:spPr>
            <a:xfrm>
              <a:off x="303073" y="2897358"/>
              <a:ext cx="546801" cy="29108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dirty="0"/>
                <a:t>Actin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xmlns="" id="{7943E7D0-E4C4-4F89-A41C-D66C378CC79E}"/>
                </a:ext>
              </a:extLst>
            </p:cNvPr>
            <p:cNvSpPr/>
            <p:nvPr/>
          </p:nvSpPr>
          <p:spPr>
            <a:xfrm>
              <a:off x="1323866" y="1221392"/>
              <a:ext cx="3084122" cy="5824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400" dirty="0"/>
                <a:t>   0        50      </a:t>
              </a:r>
              <a:r>
                <a:rPr lang="en-GB" sz="1400" dirty="0">
                  <a:solidFill>
                    <a:srgbClr val="FF0000"/>
                  </a:solidFill>
                </a:rPr>
                <a:t>125     127.5 µM 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xmlns="" id="{BCEEB148-9806-4BF2-920F-73E1257E1705}"/>
                </a:ext>
              </a:extLst>
            </p:cNvPr>
            <p:cNvSpPr/>
            <p:nvPr/>
          </p:nvSpPr>
          <p:spPr>
            <a:xfrm>
              <a:off x="4139952" y="1982841"/>
              <a:ext cx="521062" cy="52424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dirty="0"/>
                <a:t>p-p53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xmlns="" id="{3841E457-D865-4D59-A9DA-1CC6329B6501}"/>
                </a:ext>
              </a:extLst>
            </p:cNvPr>
            <p:cNvSpPr/>
            <p:nvPr/>
          </p:nvSpPr>
          <p:spPr>
            <a:xfrm>
              <a:off x="4136709" y="2901546"/>
              <a:ext cx="546801" cy="29108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dirty="0"/>
                <a:t>Actin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xmlns="" id="{DFF639A8-4ACF-49E6-9007-E910C3551BAA}"/>
                </a:ext>
              </a:extLst>
            </p:cNvPr>
            <p:cNvSpPr/>
            <p:nvPr/>
          </p:nvSpPr>
          <p:spPr>
            <a:xfrm>
              <a:off x="5463341" y="1259025"/>
              <a:ext cx="2320904" cy="5824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400" dirty="0"/>
                <a:t> 0          50        </a:t>
              </a:r>
              <a:r>
                <a:rPr lang="en-GB" sz="1400" dirty="0">
                  <a:solidFill>
                    <a:srgbClr val="FF0000"/>
                  </a:solidFill>
                </a:rPr>
                <a:t>125     127.5 µM</a:t>
              </a:r>
            </a:p>
          </p:txBody>
        </p:sp>
      </p:grpSp>
      <p:pic>
        <p:nvPicPr>
          <p:cNvPr id="9" name="Picture 4">
            <a:extLst>
              <a:ext uri="{FF2B5EF4-FFF2-40B4-BE49-F238E27FC236}">
                <a16:creationId xmlns:a16="http://schemas.microsoft.com/office/drawing/2014/main" xmlns="" id="{206077D5-A725-494F-BA99-9A381320E1F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/>
          <a:stretch/>
        </p:blipFill>
        <p:spPr bwMode="auto">
          <a:xfrm>
            <a:off x="3393584" y="3219432"/>
            <a:ext cx="1966302" cy="2492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5">
            <a:extLst>
              <a:ext uri="{FF2B5EF4-FFF2-40B4-BE49-F238E27FC236}">
                <a16:creationId xmlns:a16="http://schemas.microsoft.com/office/drawing/2014/main" xmlns="" id="{4091250E-9766-4142-8A15-09C1BAF6016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8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1" b="34347"/>
          <a:stretch/>
        </p:blipFill>
        <p:spPr bwMode="auto">
          <a:xfrm>
            <a:off x="7680276" y="3224226"/>
            <a:ext cx="2183395" cy="2444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8">
            <a:extLst>
              <a:ext uri="{FF2B5EF4-FFF2-40B4-BE49-F238E27FC236}">
                <a16:creationId xmlns:a16="http://schemas.microsoft.com/office/drawing/2014/main" xmlns="" id="{0F22EB07-5DA1-43E6-AEAD-10881949858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100000"/>
                    </a14:imgEffect>
                    <a14:imgEffect>
                      <a14:brightnessContrast bright="-44000" contrast="8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30878"/>
          <a:stretch/>
        </p:blipFill>
        <p:spPr bwMode="auto">
          <a:xfrm>
            <a:off x="3393584" y="3595705"/>
            <a:ext cx="1924976" cy="2788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9">
            <a:extLst>
              <a:ext uri="{FF2B5EF4-FFF2-40B4-BE49-F238E27FC236}">
                <a16:creationId xmlns:a16="http://schemas.microsoft.com/office/drawing/2014/main" xmlns="" id="{99A8CAEB-CC6D-4082-91BB-069E496D27D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100000"/>
                    </a14:imgEffect>
                    <a14:imgEffect>
                      <a14:brightnessContrast bright="-44000" contrast="8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25132" b="33787"/>
          <a:stretch/>
        </p:blipFill>
        <p:spPr bwMode="auto">
          <a:xfrm>
            <a:off x="7680276" y="3597240"/>
            <a:ext cx="2183396" cy="2235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5C93AE1B-1F3B-4324-9AB4-E3E6D971AC01}"/>
              </a:ext>
            </a:extLst>
          </p:cNvPr>
          <p:cNvSpPr/>
          <p:nvPr/>
        </p:nvSpPr>
        <p:spPr>
          <a:xfrm>
            <a:off x="4342908" y="3219432"/>
            <a:ext cx="1016978" cy="227225"/>
          </a:xfrm>
          <a:prstGeom prst="rect">
            <a:avLst/>
          </a:prstGeom>
          <a:noFill/>
          <a:ln w="28575" cmpd="sng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E83A0801-3F05-435D-A1DF-745A882F3CD6}"/>
              </a:ext>
            </a:extLst>
          </p:cNvPr>
          <p:cNvSpPr/>
          <p:nvPr/>
        </p:nvSpPr>
        <p:spPr>
          <a:xfrm>
            <a:off x="8800047" y="3215073"/>
            <a:ext cx="1016978" cy="227225"/>
          </a:xfrm>
          <a:prstGeom prst="rect">
            <a:avLst/>
          </a:prstGeom>
          <a:noFill/>
          <a:ln w="28575" cmpd="sng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6427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27401" y="1990726"/>
            <a:ext cx="5724525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/>
              <a:t>Online resource 3 </a:t>
            </a:r>
            <a:r>
              <a:rPr lang="en-US" dirty="0"/>
              <a:t>Cell cycle perturbations induced by OTA with a recovery period (4h treatment + 23h recovery) (n=3). Significant results from the statistical analysis (</a:t>
            </a:r>
            <a:r>
              <a:rPr lang="en-US" dirty="0" err="1"/>
              <a:t>Dunnett’s</a:t>
            </a:r>
            <a:r>
              <a:rPr lang="en-US" dirty="0"/>
              <a:t> tests) are indicated by p-values, where * = p&lt;0.05, ** = p&lt;0.01, *** = p&lt;0.001</a:t>
            </a:r>
          </a:p>
          <a:p>
            <a:pPr algn="just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79469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16300" y="1549400"/>
            <a:ext cx="5359400" cy="375920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344421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36</TotalTime>
  <Words>210</Words>
  <Application>Microsoft Office PowerPoint</Application>
  <PresentationFormat>Widescreen</PresentationFormat>
  <Paragraphs>27</Paragraphs>
  <Slides>7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Online resources (Electronic supplementary files)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Chapman</dc:creator>
  <cp:lastModifiedBy>Raja R</cp:lastModifiedBy>
  <cp:revision>53</cp:revision>
  <dcterms:created xsi:type="dcterms:W3CDTF">2020-05-15T16:27:01Z</dcterms:created>
  <dcterms:modified xsi:type="dcterms:W3CDTF">2020-09-04T11:06:18Z</dcterms:modified>
</cp:coreProperties>
</file>